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1F5081-B13E-CB75-E97D-08B338F708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6A33FE-36A3-CCF4-E9E6-1EE7E31848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C21DC2-AF6F-DD01-1498-FA1531CE9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87C7C-FB18-2114-3948-BE5C1AA52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035295-D334-B1F5-8822-79AD80089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430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4CEB5-4AD1-9507-512F-3E1089DF6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5AF6E7-DE92-E00A-210D-FBBF65DB22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74F4E-F116-ED2A-677B-AFE9B998F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81BD07-73C1-E068-C5A5-773E75219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796C6E-8FE1-5CE5-02F3-EC14E2D5C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28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DE20B0-6F8D-598D-2312-1E54C4DA3A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C02219-9541-5AE8-FD75-3F9C4287C2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BFC51-8624-6B1E-11FC-239E9DD26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0A57C-E746-902C-5DAC-90019266B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646CDF-7601-5189-9820-449AEC135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95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37AC7F-EDCC-F4FC-1F69-D9DADFC8D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5CBA8F-78FC-F97C-3B83-E61E594DD6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A74F64-6385-EE5A-F132-FF2D90166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82D96-5F94-413D-E63D-9A9D694FC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B9650-F4A3-4023-1C13-6B512FE04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96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8B3A96-188C-9D21-2FC0-5A860482D6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99EBD1-F1BA-345F-DACD-342607135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E7B0E-A5B8-4DEB-F653-AA0A42281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CE901-B5CB-5E43-094B-9391D48FB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5AD59B-6981-E3BD-7A9D-9C17B2538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215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D29AE-550B-D6E1-0F6B-F8FCA85ADA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D18CDF-D8FB-078E-AB24-7F62C143E5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E29361-2765-6F2C-FF7F-E4E85287D0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3BE045-A76E-4943-E029-A06C3B1A8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532857-79E0-D608-C24A-E44DCF7F9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DEA0A4-CCBD-AA19-692D-C51018196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732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5A4F99-86AB-BB69-5B0B-BDED92F5B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3E10EA-317B-6E59-6A87-228BB3758D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470E33-2E12-782A-E94D-39673CCFD7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95B8B1-E629-3D27-4AAB-32135025B4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C31E0C-99E2-40D6-1148-2BD7898A3F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D9239F5-BB2F-58EA-7CC2-9A1ABF7F0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73546D-2457-94BE-B903-E892EECB2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3234D1-5AF4-347D-D1DA-93C105C08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121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29244-AC03-DB47-4B93-D92B0C3D8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B7D297-1BE7-B2B0-7520-CE7FDF5CC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DE0EBD-487A-2B76-B5E1-F616D3F5A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59629F-23B2-3BA0-4EA2-2F460309E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4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E46515-2481-99F0-7DDA-789E18AE9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C96A86-30E6-CC5D-6B28-A7B2930AF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E51E5C-8997-72EC-2E6B-AC71766E4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021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387A7-AC13-A424-D6BE-3FA149004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35D758-ABE6-7BEA-D4A4-4F6216B3D6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E332B0-47A4-E84C-1DA4-C20A8F7C12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ABF2FC-6406-6C6C-7CDA-880CB541D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51762D-FF1D-3E3A-EF62-BECA8683F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D90751-1299-C895-721C-A4E903CD8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527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A4427-4F40-D349-691E-7762F2482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324F69-9047-EDAC-42FC-81A43E8819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53F661-0B01-BD6B-42F2-9DF453EC8D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1E7028-E8AC-5112-8058-C2AB78A02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1CEAA-8849-DB3E-34BD-519E99E7E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09AA5-94D4-5038-6257-80E9A95F2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282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57CF18-8773-687D-F573-AE71A0D6F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E5CA3A-8DE3-64B9-4488-E0F4B8DB34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3AAC6-619D-6C75-BE9F-C93C1535F7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1C7908-0DC1-4FA6-B4CE-F9CD2B57DFFD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45363-DEAC-D405-504A-6FF86A2FB5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760FC4-ABE6-4610-661A-9D942C8DA8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715CB1-1CF0-48F8-9045-787712B56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850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8873B1E-64D0-9DEA-3158-DDA2785DAE6A}"/>
              </a:ext>
            </a:extLst>
          </p:cNvPr>
          <p:cNvSpPr txBox="1"/>
          <p:nvPr/>
        </p:nvSpPr>
        <p:spPr>
          <a:xfrm>
            <a:off x="3722077" y="1243225"/>
            <a:ext cx="466986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2" b="1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r>
              <a:rPr lang="en-US" sz="762">
                <a:latin typeface="Arial" panose="020B0604020202020204" pitchFamily="34" charset="0"/>
                <a:cs typeface="Arial" panose="020B0604020202020204" pitchFamily="34" charset="0"/>
              </a:rPr>
              <a:t>. A direct test of </a:t>
            </a:r>
            <a:r>
              <a:rPr lang="en-US" sz="762" i="1">
                <a:latin typeface="Arial" panose="020B0604020202020204" pitchFamily="34" charset="0"/>
                <a:cs typeface="Arial" panose="020B0604020202020204" pitchFamily="34" charset="0"/>
              </a:rPr>
              <a:t>Fusobacterium</a:t>
            </a:r>
            <a:r>
              <a:rPr lang="en-US" sz="762">
                <a:latin typeface="Arial" panose="020B0604020202020204" pitchFamily="34" charset="0"/>
                <a:cs typeface="Arial" panose="020B0604020202020204" pitchFamily="34" charset="0"/>
              </a:rPr>
              <a:t> abundance by age status across the TCGA and ORIEN datasets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9CEDB267-5432-375D-61F4-CAE7F18C2DC9}"/>
              </a:ext>
            </a:extLst>
          </p:cNvPr>
          <p:cNvGrpSpPr/>
          <p:nvPr/>
        </p:nvGrpSpPr>
        <p:grpSpPr>
          <a:xfrm>
            <a:off x="4732735" y="67310"/>
            <a:ext cx="2223190" cy="1083038"/>
            <a:chOff x="1459838" y="97226"/>
            <a:chExt cx="3211275" cy="1564389"/>
          </a:xfrm>
        </p:grpSpPr>
        <p:pic>
          <p:nvPicPr>
            <p:cNvPr id="17" name="Picture 16" descr="A diagram of different types of age-related objects&#10;&#10;Description automatically generated with medium confidence">
              <a:extLst>
                <a:ext uri="{FF2B5EF4-FFF2-40B4-BE49-F238E27FC236}">
                  <a16:creationId xmlns:a16="http://schemas.microsoft.com/office/drawing/2014/main" id="{7C0C9446-D639-EBFE-7A88-3721143F2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461" b="11798"/>
            <a:stretch/>
          </p:blipFill>
          <p:spPr>
            <a:xfrm>
              <a:off x="1459838" y="97226"/>
              <a:ext cx="3211275" cy="138947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9422494-3ED5-1C2D-0C9D-F9C3981450E8}"/>
                </a:ext>
              </a:extLst>
            </p:cNvPr>
            <p:cNvSpPr txBox="1"/>
            <p:nvPr/>
          </p:nvSpPr>
          <p:spPr>
            <a:xfrm>
              <a:off x="2044785" y="1374406"/>
              <a:ext cx="433452" cy="28720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92"/>
                <a:t>EO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BBEE8A7-3843-C902-6161-2989051D4314}"/>
                </a:ext>
              </a:extLst>
            </p:cNvPr>
            <p:cNvSpPr txBox="1"/>
            <p:nvPr/>
          </p:nvSpPr>
          <p:spPr>
            <a:xfrm>
              <a:off x="2663214" y="1371829"/>
              <a:ext cx="438083" cy="28720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92"/>
                <a:t>AO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6B7134D-25B2-1ACC-818F-62342B954FB4}"/>
                </a:ext>
              </a:extLst>
            </p:cNvPr>
            <p:cNvSpPr txBox="1"/>
            <p:nvPr/>
          </p:nvSpPr>
          <p:spPr>
            <a:xfrm>
              <a:off x="3477343" y="1365627"/>
              <a:ext cx="433452" cy="28720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92"/>
                <a:t>EO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7B007B8-3D4D-6AA0-B3B5-A20990BDC8F9}"/>
                </a:ext>
              </a:extLst>
            </p:cNvPr>
            <p:cNvSpPr txBox="1"/>
            <p:nvPr/>
          </p:nvSpPr>
          <p:spPr>
            <a:xfrm>
              <a:off x="4098349" y="1363050"/>
              <a:ext cx="438083" cy="28720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92"/>
                <a:t>AO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DCF9E136-33EA-2393-BEDC-482A7A2B1646}"/>
              </a:ext>
            </a:extLst>
          </p:cNvPr>
          <p:cNvSpPr txBox="1"/>
          <p:nvPr/>
        </p:nvSpPr>
        <p:spPr>
          <a:xfrm>
            <a:off x="201168" y="67310"/>
            <a:ext cx="3310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3767248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db864bc-821c-4dd3-a9c9-5002b5129ec6}" enabled="1" method="Standard" siteId="{0b95a125-791c-4f0a-9f9e-99e36311750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n, Ning</dc:creator>
  <cp:lastModifiedBy>Dahlberg, Angela</cp:lastModifiedBy>
  <cp:revision>2</cp:revision>
  <dcterms:created xsi:type="dcterms:W3CDTF">2025-09-09T02:31:52Z</dcterms:created>
  <dcterms:modified xsi:type="dcterms:W3CDTF">2025-10-16T20:15:55Z</dcterms:modified>
</cp:coreProperties>
</file>